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662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29.png"/><Relationship Id="rId18" Type="http://schemas.microsoft.com/office/2007/relationships/hdphoto" Target="../media/hdphoto2.wdp"/><Relationship Id="rId3" Type="http://schemas.openxmlformats.org/officeDocument/2006/relationships/image" Target="../media/image20.png"/><Relationship Id="rId21" Type="http://schemas.openxmlformats.org/officeDocument/2006/relationships/image" Target="../media/image36.png"/><Relationship Id="rId7" Type="http://schemas.openxmlformats.org/officeDocument/2006/relationships/image" Target="../media/image24.png"/><Relationship Id="rId12" Type="http://schemas.openxmlformats.org/officeDocument/2006/relationships/image" Target="../media/image28.png"/><Relationship Id="rId17" Type="http://schemas.openxmlformats.org/officeDocument/2006/relationships/image" Target="../media/image33.png"/><Relationship Id="rId2" Type="http://schemas.openxmlformats.org/officeDocument/2006/relationships/image" Target="../media/image19.png"/><Relationship Id="rId16" Type="http://schemas.openxmlformats.org/officeDocument/2006/relationships/image" Target="../media/image32.png"/><Relationship Id="rId20" Type="http://schemas.openxmlformats.org/officeDocument/2006/relationships/image" Target="../media/image35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3.png"/><Relationship Id="rId11" Type="http://schemas.openxmlformats.org/officeDocument/2006/relationships/image" Target="../media/image27.png"/><Relationship Id="rId5" Type="http://schemas.openxmlformats.org/officeDocument/2006/relationships/image" Target="../media/image22.png"/><Relationship Id="rId15" Type="http://schemas.openxmlformats.org/officeDocument/2006/relationships/image" Target="../media/image31.png"/><Relationship Id="rId23" Type="http://schemas.openxmlformats.org/officeDocument/2006/relationships/image" Target="../media/image37.png"/><Relationship Id="rId10" Type="http://schemas.openxmlformats.org/officeDocument/2006/relationships/image" Target="../media/image26.png"/><Relationship Id="rId19" Type="http://schemas.openxmlformats.org/officeDocument/2006/relationships/image" Target="../media/image34.png"/><Relationship Id="rId4" Type="http://schemas.openxmlformats.org/officeDocument/2006/relationships/image" Target="../media/image21.png"/><Relationship Id="rId9" Type="http://schemas.openxmlformats.org/officeDocument/2006/relationships/image" Target="../media/image25.png"/><Relationship Id="rId14" Type="http://schemas.openxmlformats.org/officeDocument/2006/relationships/image" Target="../media/image30.png"/><Relationship Id="rId22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sv-SE" dirty="0" smtClean="0"/>
              <a:t/>
            </a:r>
            <a:br>
              <a:rPr lang="sv-SE" dirty="0" smtClean="0"/>
            </a:br>
            <a:r>
              <a:rPr lang="sv-SE" dirty="0" smtClean="0"/>
              <a:t/>
            </a:r>
            <a:br>
              <a:rPr lang="sv-SE" dirty="0" smtClean="0"/>
            </a:br>
            <a:endParaRPr lang="sv-SE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3950" y="2590801"/>
            <a:ext cx="1477799" cy="399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5373" y="3276600"/>
            <a:ext cx="1476375" cy="4079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3950" y="3964228"/>
            <a:ext cx="1477798" cy="3791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5374" y="4600575"/>
            <a:ext cx="1476375" cy="428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5375" y="5257800"/>
            <a:ext cx="1476374" cy="476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6145" y="6007350"/>
            <a:ext cx="1465603" cy="393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3775" y="2609850"/>
            <a:ext cx="1457325" cy="3835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3775" y="3300280"/>
            <a:ext cx="1457325" cy="419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0" name="Picture 16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3775" y="3979492"/>
            <a:ext cx="1457325" cy="4455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1" name="Picture 17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3775" y="4623276"/>
            <a:ext cx="1457325" cy="4611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2" name="Picture 18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3775" y="5274893"/>
            <a:ext cx="1457325" cy="3974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3" name="Picture 19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3775" y="6024442"/>
            <a:ext cx="1495425" cy="352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4" name="Picture 20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0724" y="2614176"/>
            <a:ext cx="1524000" cy="352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5" name="Picture 21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4641" y="3302239"/>
            <a:ext cx="1528629" cy="4094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6" name="Picture 22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52892" y="3989271"/>
            <a:ext cx="1557470" cy="270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7" name="Picture 23"/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52890" y="4665292"/>
            <a:ext cx="1557471" cy="3647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8" name="Picture 24"/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1437" y="5292652"/>
            <a:ext cx="1557471" cy="3257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9" name="Picture 25"/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53959" y="6051783"/>
            <a:ext cx="1564949" cy="3094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" name="TextBox 21"/>
          <p:cNvSpPr txBox="1"/>
          <p:nvPr/>
        </p:nvSpPr>
        <p:spPr>
          <a:xfrm>
            <a:off x="3276600" y="1831677"/>
            <a:ext cx="228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Du145     </a:t>
            </a:r>
            <a:r>
              <a:rPr lang="en-US" altLang="zh-CN" sz="1200" b="1" dirty="0" smtClean="0">
                <a:solidFill>
                  <a:srgbClr val="00B0F0"/>
                </a:solidFill>
              </a:rPr>
              <a:t>Du145-R</a:t>
            </a:r>
            <a:r>
              <a:rPr lang="en-US" altLang="zh-CN" sz="1200" b="1" dirty="0" smtClean="0"/>
              <a:t>     Du145-RB</a:t>
            </a:r>
            <a:endParaRPr lang="zh-CN" altLang="en-US" sz="1200" b="1" dirty="0"/>
          </a:p>
        </p:txBody>
      </p:sp>
      <p:cxnSp>
        <p:nvCxnSpPr>
          <p:cNvPr id="24" name="Straight Connector 23"/>
          <p:cNvCxnSpPr/>
          <p:nvPr/>
        </p:nvCxnSpPr>
        <p:spPr>
          <a:xfrm>
            <a:off x="1905000" y="2057400"/>
            <a:ext cx="4645662" cy="0"/>
          </a:xfrm>
          <a:prstGeom prst="line">
            <a:avLst/>
          </a:prstGeom>
          <a:ln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1123950" y="2390001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>
                <a:solidFill>
                  <a:srgbClr val="0070C0"/>
                </a:solidFill>
              </a:rPr>
              <a:t>    </a:t>
            </a:r>
            <a:r>
              <a:rPr lang="en-US" altLang="zh-CN" sz="1200" b="1" dirty="0">
                <a:solidFill>
                  <a:srgbClr val="0070C0"/>
                </a:solidFill>
              </a:rPr>
              <a:t>ROBO1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123950" y="3067969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>
                <a:solidFill>
                  <a:srgbClr val="0070C0"/>
                </a:solidFill>
              </a:rPr>
              <a:t>IL32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123950" y="3753055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>
                <a:solidFill>
                  <a:srgbClr val="0070C0"/>
                </a:solidFill>
              </a:rPr>
              <a:t> </a:t>
            </a:r>
            <a:r>
              <a:rPr lang="en-US" altLang="zh-CN" sz="1200" b="1" dirty="0">
                <a:solidFill>
                  <a:srgbClr val="0070C0"/>
                </a:solidFill>
              </a:rPr>
              <a:t>ZBED2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123950" y="4388293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>
                <a:solidFill>
                  <a:srgbClr val="0070C0"/>
                </a:solidFill>
              </a:rPr>
              <a:t>CD74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123950" y="5048455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solidFill>
                  <a:srgbClr val="0070C0"/>
                </a:solidFill>
              </a:rPr>
              <a:t>CYBA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123950" y="5786569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F13A1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506713" y="2404930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>
                <a:solidFill>
                  <a:srgbClr val="0070C0"/>
                </a:solidFill>
              </a:rPr>
              <a:t>    </a:t>
            </a:r>
            <a:r>
              <a:rPr lang="en-US" altLang="zh-CN" sz="1200" b="1" dirty="0">
                <a:solidFill>
                  <a:srgbClr val="0070C0"/>
                </a:solidFill>
              </a:rPr>
              <a:t>LPCAT2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506713" y="3082898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ZNF518B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506713" y="3767984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solidFill>
                  <a:srgbClr val="0070C0"/>
                </a:solidFill>
              </a:rPr>
              <a:t> C9orf125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506713" y="4403222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GNA15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506713" y="5063384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ATP10A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506713" y="5801498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CLCN4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811763" y="2404930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>
                <a:solidFill>
                  <a:srgbClr val="0070C0"/>
                </a:solidFill>
              </a:rPr>
              <a:t>    </a:t>
            </a:r>
            <a:r>
              <a:rPr lang="en-US" altLang="zh-CN" sz="1200" b="1" dirty="0">
                <a:solidFill>
                  <a:srgbClr val="0070C0"/>
                </a:solidFill>
              </a:rPr>
              <a:t>PLAU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811763" y="3082898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LTB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5811763" y="3767984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solidFill>
                  <a:srgbClr val="0070C0"/>
                </a:solidFill>
              </a:rPr>
              <a:t> ABCB1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5811763" y="4403222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ST6GALNAC5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811763" y="5063384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GPX7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5811763" y="5801498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C10orf85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45" name="Title 1"/>
          <p:cNvSpPr txBox="1">
            <a:spLocks/>
          </p:cNvSpPr>
          <p:nvPr/>
        </p:nvSpPr>
        <p:spPr>
          <a:xfrm>
            <a:off x="609600" y="4270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sv-SE" dirty="0" smtClean="0"/>
              <a:t>Up-regulated genes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26040451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sv-SE" dirty="0" smtClean="0"/>
              <a:t>Down-regulated genes</a:t>
            </a:r>
            <a:endParaRPr lang="sv-SE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7718" y="2366420"/>
            <a:ext cx="1519282" cy="4051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3474" y="3050129"/>
            <a:ext cx="1533525" cy="447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7717" y="3744653"/>
            <a:ext cx="1519282" cy="3867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3474" y="4371166"/>
            <a:ext cx="1533526" cy="4658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1278" y="5031329"/>
            <a:ext cx="1515721" cy="3504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7717" y="5659134"/>
            <a:ext cx="1504950" cy="504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4304" y="2365975"/>
            <a:ext cx="1475842" cy="4612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4304" y="3047836"/>
            <a:ext cx="1476375" cy="371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3354" y="3726292"/>
            <a:ext cx="1456792" cy="4149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2821" y="4356767"/>
            <a:ext cx="1457325" cy="419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7480" y="5018887"/>
            <a:ext cx="1463199" cy="339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3354" y="5658704"/>
            <a:ext cx="1456792" cy="3824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65085" y="2363224"/>
            <a:ext cx="1457325" cy="428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1" name="Picture 17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65085" y="3037194"/>
            <a:ext cx="1457325" cy="2914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3" name="Picture 19"/>
          <p:cNvPicPr>
            <a:picLocks noChangeAspect="1" noChangeArrowheads="1"/>
          </p:cNvPicPr>
          <p:nvPr/>
        </p:nvPicPr>
        <p:blipFill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65085" y="3718451"/>
            <a:ext cx="1457325" cy="3323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4" name="Picture 20"/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65085" y="4349780"/>
            <a:ext cx="1457325" cy="377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5" name="Picture 21"/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65084" y="5021935"/>
            <a:ext cx="1457325" cy="3940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6" name="Picture 22"/>
          <p:cNvPicPr>
            <a:picLocks noChangeAspect="1" noChangeArrowheads="1"/>
          </p:cNvPicPr>
          <p:nvPr/>
        </p:nvPicPr>
        <p:blipFill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65085" y="5642666"/>
            <a:ext cx="1457324" cy="3771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8" name="Picture 24"/>
          <p:cNvPicPr>
            <a:picLocks noChangeAspect="1" noChangeArrowheads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97844" y="6340701"/>
            <a:ext cx="1424566" cy="2886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1123950" y="2148529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>
                <a:solidFill>
                  <a:srgbClr val="0070C0"/>
                </a:solidFill>
              </a:rPr>
              <a:t>    </a:t>
            </a:r>
            <a:r>
              <a:rPr lang="en-US" altLang="zh-CN" sz="1200" b="1" dirty="0">
                <a:solidFill>
                  <a:srgbClr val="0070C0"/>
                </a:solidFill>
              </a:rPr>
              <a:t>ALPPL2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123950" y="2826497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RPS4Y1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123950" y="3511583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solidFill>
                  <a:srgbClr val="0070C0"/>
                </a:solidFill>
              </a:rPr>
              <a:t> H19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123950" y="4146821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TESC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123950" y="4824075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AKR1C2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123950" y="5440058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INSL4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703801" y="2133600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>
                <a:solidFill>
                  <a:srgbClr val="0070C0"/>
                </a:solidFill>
              </a:rPr>
              <a:t>    </a:t>
            </a:r>
            <a:r>
              <a:rPr lang="en-US" altLang="zh-CN" sz="1200" b="1" dirty="0">
                <a:solidFill>
                  <a:srgbClr val="0070C0"/>
                </a:solidFill>
              </a:rPr>
              <a:t>METTL7A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703801" y="2811568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RAB25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703801" y="3496654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 smtClean="0">
                <a:solidFill>
                  <a:srgbClr val="0070C0"/>
                </a:solidFill>
              </a:rPr>
              <a:t> FOLR1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703801" y="4131892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ALPP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703801" y="4809146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CPS1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703801" y="5425129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CYP4F3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6447001" y="2133600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>
                <a:solidFill>
                  <a:srgbClr val="0070C0"/>
                </a:solidFill>
              </a:rPr>
              <a:t>    </a:t>
            </a:r>
            <a:r>
              <a:rPr lang="en-US" altLang="zh-CN" sz="1200" b="1" dirty="0">
                <a:solidFill>
                  <a:srgbClr val="0070C0"/>
                </a:solidFill>
              </a:rPr>
              <a:t>NCAM1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6447001" y="2811568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DDX3Y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6447001" y="3496654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 FXYD3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6447001" y="4131892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TMPRSS13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447001" y="4809146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FGA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6447001" y="5425129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ZNF675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6451362" y="6123801"/>
            <a:ext cx="1477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altLang="zh-CN" sz="1200" b="1" dirty="0">
                <a:solidFill>
                  <a:srgbClr val="0070C0"/>
                </a:solidFill>
              </a:rPr>
              <a:t>SOX21</a:t>
            </a:r>
            <a:endParaRPr lang="zh-CN" altLang="en-US" sz="1200" b="1" dirty="0">
              <a:solidFill>
                <a:srgbClr val="0070C0"/>
              </a:solidFill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276600" y="1752600"/>
            <a:ext cx="228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Du145     </a:t>
            </a:r>
            <a:r>
              <a:rPr lang="en-US" altLang="zh-CN" sz="1200" b="1" dirty="0" smtClean="0">
                <a:solidFill>
                  <a:srgbClr val="00B0F0"/>
                </a:solidFill>
              </a:rPr>
              <a:t>Du145-R</a:t>
            </a:r>
            <a:r>
              <a:rPr lang="en-US" altLang="zh-CN" sz="1200" b="1" dirty="0" smtClean="0"/>
              <a:t>     Du145-RB</a:t>
            </a:r>
            <a:endParaRPr lang="zh-CN" altLang="en-US" sz="1200" b="1" dirty="0"/>
          </a:p>
        </p:txBody>
      </p:sp>
      <p:cxnSp>
        <p:nvCxnSpPr>
          <p:cNvPr id="52" name="Straight Connector 51"/>
          <p:cNvCxnSpPr/>
          <p:nvPr/>
        </p:nvCxnSpPr>
        <p:spPr>
          <a:xfrm>
            <a:off x="1905000" y="1978323"/>
            <a:ext cx="4645662" cy="0"/>
          </a:xfrm>
          <a:prstGeom prst="line">
            <a:avLst/>
          </a:prstGeom>
          <a:ln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471269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</TotalTime>
  <Words>59</Words>
  <Application>Microsoft Office PowerPoint</Application>
  <PresentationFormat>On-screen Show (4:3)</PresentationFormat>
  <Paragraphs>4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  </vt:lpstr>
      <vt:lpstr>Down-regulated genes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anjun Ma</dc:creator>
  <cp:lastModifiedBy>Yuanjun Ma</cp:lastModifiedBy>
  <cp:revision>71</cp:revision>
  <dcterms:created xsi:type="dcterms:W3CDTF">2006-08-16T00:00:00Z</dcterms:created>
  <dcterms:modified xsi:type="dcterms:W3CDTF">2015-09-21T11:27:51Z</dcterms:modified>
</cp:coreProperties>
</file>